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7F97DE"/>
    <a:srgbClr val="FFFDF7"/>
    <a:srgbClr val="F2DCDB"/>
    <a:srgbClr val="AA7DA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0" d="100"/>
          <a:sy n="100" d="100"/>
        </p:scale>
        <p:origin x="1836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7/05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5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5/2020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5/2020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5/2020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5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7/05/2020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7/05/2020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D5A0C22-28FD-4610-ACAB-DB99FC6B5B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83964" y="692696"/>
            <a:ext cx="5776072" cy="5070046"/>
          </a:xfrm>
          <a:prstGeom prst="rect">
            <a:avLst/>
          </a:prstGeom>
          <a:ln>
            <a:noFill/>
          </a:ln>
        </p:spPr>
      </p:pic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Katulanda</a:t>
            </a:r>
            <a:r>
              <a:rPr lang="en-GB" dirty="0"/>
              <a:t> et al (2020) Diabetologia DOI 10.1007/s00125-020-05164-x 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5"/>
              </a:rPr>
              <a:t>http://creativecommons.org/licenses/by/4.0/</a:t>
            </a:r>
            <a:r>
              <a:rPr lang="en-GB" sz="1200" dirty="0"/>
              <a:t>)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15007"/>
            <a:ext cx="87129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Role of ACE2 in the pathogenesis of coronavirus </a:t>
            </a:r>
          </a:p>
        </p:txBody>
      </p:sp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72CF3CF3-F78C-461C-B1CD-D0256FE66A52}"/>
              </a:ext>
            </a:extLst>
          </p:cNvPr>
          <p:cNvSpPr txBox="1"/>
          <p:nvPr/>
        </p:nvSpPr>
        <p:spPr>
          <a:xfrm>
            <a:off x="251520" y="5661248"/>
            <a:ext cx="7128792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r>
              <a:rPr lang="en-GB" dirty="0" err="1"/>
              <a:t>Katulanda</a:t>
            </a:r>
            <a:r>
              <a:rPr lang="en-GB" dirty="0"/>
              <a:t> et al (2020) Diabetologia DOI 10.1007/s00125-020-05164-x </a:t>
            </a:r>
          </a:p>
          <a:p>
            <a:r>
              <a:rPr lang="en-GB" sz="1200" dirty="0"/>
              <a:t>©The Authors 2020. Distributed under the terms of the CC BY 4.0 Attribution License (</a:t>
            </a:r>
            <a:r>
              <a:rPr lang="en-GB" sz="1200" dirty="0">
                <a:hlinkClick r:id="rId2"/>
              </a:rPr>
              <a:t>http://creativecommons.org/licenses/by/4.0/</a:t>
            </a:r>
            <a:r>
              <a:rPr lang="en-GB" sz="1200" dirty="0"/>
              <a:t>) </a:t>
            </a:r>
          </a:p>
        </p:txBody>
      </p:sp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60737135-D2F8-4F65-B06B-C1BFA89F2CB7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D983C99-B078-4E30-9E38-69CD628D871E}"/>
              </a:ext>
            </a:extLst>
          </p:cNvPr>
          <p:cNvSpPr txBox="1"/>
          <p:nvPr/>
        </p:nvSpPr>
        <p:spPr>
          <a:xfrm>
            <a:off x="323528" y="5715"/>
            <a:ext cx="871296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b="1" dirty="0"/>
              <a:t>COVID-19 preventive and management considerations for people with diabetes</a:t>
            </a:r>
            <a:r>
              <a:rPr lang="en-GB" sz="2400" dirty="0"/>
              <a:t> </a:t>
            </a:r>
            <a:endParaRPr lang="en-GB" sz="2400" b="1" dirty="0"/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31EC3FFD-D4F5-49E9-BFF8-DF5C6AE6EE3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1864" y="1084049"/>
            <a:ext cx="8420271" cy="45711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71615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7</TotalTime>
  <Words>98</Words>
  <Application>Microsoft Office PowerPoint</Application>
  <PresentationFormat>On-screen Show (4:3)</PresentationFormat>
  <Paragraphs>9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42</cp:revision>
  <dcterms:created xsi:type="dcterms:W3CDTF">2016-06-15T12:53:43Z</dcterms:created>
  <dcterms:modified xsi:type="dcterms:W3CDTF">2020-05-07T10:35:08Z</dcterms:modified>
</cp:coreProperties>
</file>